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40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161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986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4341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181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032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351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767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47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295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836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E37A8-B72B-44FF-8F1B-6D14D43E8C5B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7FC14-4192-4BEC-8604-10F7531E5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532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91680" y="649233"/>
            <a:ext cx="565212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.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Control of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JD2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transcription in human islets by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NP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rs3743123</a:t>
            </a:r>
            <a:endParaRPr lang="en-US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5296428"/>
              </p:ext>
            </p:extLst>
          </p:nvPr>
        </p:nvGraphicFramePr>
        <p:xfrm>
          <a:off x="2042828" y="1269921"/>
          <a:ext cx="4949825" cy="1760220"/>
        </p:xfrm>
        <a:graphic>
          <a:graphicData uri="http://schemas.openxmlformats.org/drawingml/2006/table">
            <a:tbl>
              <a:tblPr firstRow="1" firstCol="1" bandRow="1"/>
              <a:tblGrid>
                <a:gridCol w="1330960"/>
                <a:gridCol w="918845"/>
                <a:gridCol w="1350010"/>
                <a:gridCol w="1350010"/>
              </a:tblGrid>
              <a:tr h="0"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group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Cx36 mRNA levels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normoglycemic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all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8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9.55 ± 0.06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wome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33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9.42 ± 0.11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me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48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9.64 ± 0.06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3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T2D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all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47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9.34 ± 0.10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wome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19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9.37 ± 0.16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men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R="111125"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Times New Roman"/>
                          <a:ea typeface="Times New Roman"/>
                        </a:rPr>
                        <a:t>28</a:t>
                      </a:r>
                      <a:endParaRPr lang="en-US" sz="12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Times New Roman"/>
                          <a:ea typeface="Times New Roman"/>
                        </a:rPr>
                        <a:t>9.32 ± 0.12*</a:t>
                      </a:r>
                      <a:endParaRPr lang="en-US" sz="12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853444" y="3188876"/>
            <a:ext cx="5328592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ression of Cx36 mRNA resulting from microarray gene expression profile.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lue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re mean ± SD of the indicated number of cases. *p = 0.032 vs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normoglycemic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en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3947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2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9</cp:revision>
  <dcterms:created xsi:type="dcterms:W3CDTF">2015-03-29T16:39:15Z</dcterms:created>
  <dcterms:modified xsi:type="dcterms:W3CDTF">2015-11-15T16:30:39Z</dcterms:modified>
</cp:coreProperties>
</file>